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F843D-71C8-4B14-9533-76BEF8E75D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8C4F4-161F-4530-B7E4-28BE5A7A0F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3A824-E2D7-4D44-8ADA-76FD237E1D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42423-2DD6-4C34-99DF-0A960EEE49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021EC-B20E-4BB6-9B39-3C1008F62B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99987-9D51-4836-BB13-ED3CAF224D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3C02D-DA10-4BD4-B920-95E81BB03A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E54A9-2A59-45B8-8AAE-E43856149A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EDF93-67B3-41C7-BFC1-85FE7500D2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4AB2B-B7D9-44BE-99C7-EBD525E41C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1FE9B-F2A2-4A29-91C4-7B983A6960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03BE3-90B3-4EB6-9D9A-8F40DFC6BD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38D462-6D25-4D48-B859-A6905FD317A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85840" y="428760"/>
            <a:ext cx="850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2. Bias plots for MAQC data using procedure 3 and comparing with reweighting method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357120" y="1378080"/>
            <a:ext cx="8550360" cy="492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32:31Z</dcterms:created>
  <dc:creator>Wei Zheng</dc:creator>
  <dc:description/>
  <dc:language>en-US</dc:language>
  <cp:lastModifiedBy>Wei Zheng</cp:lastModifiedBy>
  <dcterms:modified xsi:type="dcterms:W3CDTF">2011-06-06T17:32:43Z</dcterms:modified>
  <cp:revision>1</cp:revision>
  <dc:subject/>
  <dc:title>Slide 1</dc:title>
</cp:coreProperties>
</file>